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Inge  Thijssen - van Loosdregt" initials="ITvL" lastIdx="1" clrIdx="0">
    <p:extLst>
      <p:ext uri="{19B8F6BF-5375-455C-9EA6-DF929625EA0E}">
        <p15:presenceInfo xmlns:p15="http://schemas.microsoft.com/office/powerpoint/2012/main" userId="S::inge.thijssen@cytosmart.com::706eef2f-805a-4b0c-ad4e-9021a244958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2745BE1-A151-4FAB-B11E-2C69CF270CE4}" v="1" dt="2021-01-15T11:36:38.87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73" d="100"/>
          <a:sy n="73" d="100"/>
        </p:scale>
        <p:origin x="106" y="43"/>
      </p:cViewPr>
      <p:guideLst>
        <p:guide orient="horz" pos="218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01B39BB-F659-4D5B-A160-C03739421C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672FAD37-6D18-499F-9957-89FB0DC349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5C814F1-1218-42BD-9DC5-8468F7CA77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2A8F7-6D0D-4DD3-8AC6-211E706285B2}" type="datetimeFigureOut">
              <a:rPr lang="en-US" smtClean="0"/>
              <a:t>1/20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37B7C0C-28F4-4102-8745-AA9DC0D1DD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106815E-6829-48CB-B597-E9CF9F86BF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575BB-6CDE-49F3-9E7F-C5BB77BE12C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03720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D20EB76-906D-4EA0-B20F-D3795C0C6C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2EE32A53-4984-4820-94C7-1AE227C1EB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B70DE81-48FD-451A-9AE3-D4EBEDFD2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2A8F7-6D0D-4DD3-8AC6-211E706285B2}" type="datetimeFigureOut">
              <a:rPr lang="en-US" smtClean="0"/>
              <a:t>1/20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2B38CE7-0F43-4C1C-9A69-EEBF2053D4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DBFC401-23A8-4990-882B-82AB7CA673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575BB-6CDE-49F3-9E7F-C5BB77BE12C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1304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52FB0205-6333-4C6A-9BED-2EB5203408D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22360F26-2733-45A5-8947-5F7144E825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C943905-DBF0-404A-97B3-D3BBD619EE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2A8F7-6D0D-4DD3-8AC6-211E706285B2}" type="datetimeFigureOut">
              <a:rPr lang="en-US" smtClean="0"/>
              <a:t>1/20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68D1F6F-4A1E-4C71-A0AB-8B00ED5C8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20EEBFB-7155-4D1F-AA2C-C610A18124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575BB-6CDE-49F3-9E7F-C5BB77BE12C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9355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B58F604-9BA9-4902-BE4B-9FFE6EF4A8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01DB3CA-D5B0-40F4-88F2-C9BCFB32A49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ADDB83E-9083-47EC-BE4F-B9006147ED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2A8F7-6D0D-4DD3-8AC6-211E706285B2}" type="datetimeFigureOut">
              <a:rPr lang="en-US" smtClean="0"/>
              <a:t>1/20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9C238D3-9574-4EAD-8D07-25D6B8BB84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B7064B9-85C8-4DA7-AC29-D400D114F1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575BB-6CDE-49F3-9E7F-C5BB77BE12C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6548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FA0E091-1420-4AAD-8C43-1F2EAF8130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E0F89F9-7790-447B-B596-72DC43441A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98E52F8-F4EE-43D1-8B07-F489F77FB9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2A8F7-6D0D-4DD3-8AC6-211E706285B2}" type="datetimeFigureOut">
              <a:rPr lang="en-US" smtClean="0"/>
              <a:t>1/20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6786236-021B-40DB-A99B-3F0470D249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C1F90A2-3101-4043-B397-90E1167470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575BB-6CDE-49F3-9E7F-C5BB77BE12C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6336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2EBD858-F74A-4234-A93E-E40AF421EA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CC58EF3-E5EA-4C96-92ED-F406EBA5DF3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7B33682C-ECB9-45DF-87CE-F3F8A65C14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71D0830C-AF25-4FE6-A33B-C60769EB75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2A8F7-6D0D-4DD3-8AC6-211E706285B2}" type="datetimeFigureOut">
              <a:rPr lang="en-US" smtClean="0"/>
              <a:t>1/20/2021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382FC3F-05A2-431B-A2C5-97A7D3C0F5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F556F1E-1239-481E-BFC2-9ECC11FC18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575BB-6CDE-49F3-9E7F-C5BB77BE12C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327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374C5F6-AC6B-4A4C-9A44-C6EF10E2DE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E4711B5-26B6-43FF-8D5D-47AB87E39E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ACDF23E-D491-4B19-B706-0EA01E760E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E8FB9D27-8E4B-4F95-A7E5-250DF4F9281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62E3311A-7AB9-4254-9886-23F87F38EB8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57AFE986-8299-4881-99A5-5751E60FD2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2A8F7-6D0D-4DD3-8AC6-211E706285B2}" type="datetimeFigureOut">
              <a:rPr lang="en-US" smtClean="0"/>
              <a:t>1/20/2021</a:t>
            </a:fld>
            <a:endParaRPr lang="en-US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6C4F89EA-FF13-4A88-B435-B2BF162CF9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B79B823D-55A4-440A-8C3F-E45380FFD9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575BB-6CDE-49F3-9E7F-C5BB77BE12C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43978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4C29DA5-B1FF-44D4-BF90-DD8F79D63B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8B11D454-6411-49D0-907A-FC7CD331D3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2A8F7-6D0D-4DD3-8AC6-211E706285B2}" type="datetimeFigureOut">
              <a:rPr lang="en-US" smtClean="0"/>
              <a:t>1/20/2021</a:t>
            </a:fld>
            <a:endParaRPr lang="en-US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50C5E65C-8A94-4E95-A77C-88BA580D4A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C1FFEC43-7579-43F5-9D47-A49383E779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575BB-6CDE-49F3-9E7F-C5BB77BE12C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82363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6996F6BD-37C3-4F7C-847A-FD72A1EF27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2A8F7-6D0D-4DD3-8AC6-211E706285B2}" type="datetimeFigureOut">
              <a:rPr lang="en-US" smtClean="0"/>
              <a:t>1/20/2021</a:t>
            </a:fld>
            <a:endParaRPr lang="en-US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2E2988F7-637F-4916-B90F-CD324620B0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EC2C68C0-5778-4A62-9034-C3721E85B9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575BB-6CDE-49F3-9E7F-C5BB77BE12C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1836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F43F1A4-48AF-4339-BD52-1DD1F8CF7A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08221DD-AAA4-4C77-B090-51A454557A9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41514840-0351-4A70-AE06-E06C92B016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582CBA9-A76C-4E94-AFB4-0A2FF9EDA0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2A8F7-6D0D-4DD3-8AC6-211E706285B2}" type="datetimeFigureOut">
              <a:rPr lang="en-US" smtClean="0"/>
              <a:t>1/20/2021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5A50239-8484-4B78-A32D-92749B2ED7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7FCF793-AB64-45FD-8642-40E0BA375E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575BB-6CDE-49F3-9E7F-C5BB77BE12C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4575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F2B8E47-F547-4991-832B-DC7A9231CB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4EC95FB7-DA35-42C9-BD12-13AC35B6D63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C39408B-F67D-4D37-94D6-90B86E4FB2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ED41AEA-2C45-4F24-A76C-16954A647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2A8F7-6D0D-4DD3-8AC6-211E706285B2}" type="datetimeFigureOut">
              <a:rPr lang="en-US" smtClean="0"/>
              <a:t>1/20/2021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4FFDC77-AF21-444A-B2FF-E501F9A683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1843C93-A1C0-4E98-8FF3-A9AF3FC7C4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575BB-6CDE-49F3-9E7F-C5BB77BE12C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96999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A9552592-DBD3-4D0C-920E-4A5252E0AE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37BA79C-80F4-47F9-8ECC-E13BDDB04C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D5C60BB-DA52-49B6-B07D-1E9F2C33449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E2A8F7-6D0D-4DD3-8AC6-211E706285B2}" type="datetimeFigureOut">
              <a:rPr lang="en-US" smtClean="0"/>
              <a:t>1/20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F730855-76E7-480F-A14C-4E1B3FC97CC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6A2A7B9-34A5-4C34-B092-098A89C3A3C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B575BB-6CDE-49F3-9E7F-C5BB77BE12C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72885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avi"/><Relationship Id="rId7" Type="http://schemas.openxmlformats.org/officeDocument/2006/relationships/image" Target="../media/image2.png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avi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Untertitel 2">
            <a:extLst>
              <a:ext uri="{FF2B5EF4-FFF2-40B4-BE49-F238E27FC236}">
                <a16:creationId xmlns:a16="http://schemas.microsoft.com/office/drawing/2014/main" id="{A3D8BADE-3FB7-4A2C-8695-097A95BCC7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545224" y="6145541"/>
            <a:ext cx="10921561" cy="1655762"/>
          </a:xfrm>
        </p:spPr>
        <p:txBody>
          <a:bodyPr>
            <a:normAutofit/>
          </a:bodyPr>
          <a:lstStyle/>
          <a:p>
            <a:pPr algn="l"/>
            <a:r>
              <a:rPr lang="en-US" sz="1600" b="1" dirty="0"/>
              <a:t>Suppl. Figure 1. </a:t>
            </a:r>
            <a:r>
              <a:rPr lang="en-US" sz="1600" dirty="0" err="1"/>
              <a:t>Astroglial</a:t>
            </a:r>
            <a:r>
              <a:rPr lang="en-US" sz="1600" dirty="0"/>
              <a:t> primary cultures (APC) from 3xTg-AD mouse brains were tracked without (a) and with 1</a:t>
            </a:r>
            <a:r>
              <a:rPr lang="el-GR" sz="1600" dirty="0"/>
              <a:t>μ</a:t>
            </a:r>
            <a:r>
              <a:rPr lang="de-DE" sz="1600" dirty="0"/>
              <a:t>M </a:t>
            </a:r>
            <a:r>
              <a:rPr lang="de-DE" sz="1600" dirty="0" err="1"/>
              <a:t>losartan</a:t>
            </a:r>
            <a:r>
              <a:rPr lang="de-DE" sz="1600" dirty="0"/>
              <a:t> </a:t>
            </a:r>
            <a:r>
              <a:rPr lang="en-US" sz="1600" dirty="0"/>
              <a:t>(b) for 24 hours. The images were taken every 15 minutes. The tracking analysis was performed using ImageJ plug-in “</a:t>
            </a:r>
            <a:r>
              <a:rPr lang="en-US" sz="1600" dirty="0" err="1"/>
              <a:t>TrackMate</a:t>
            </a:r>
            <a:r>
              <a:rPr lang="en-US" sz="1600" dirty="0"/>
              <a:t>” as described in the methods part of the article.</a:t>
            </a:r>
          </a:p>
        </p:txBody>
      </p:sp>
      <p:pic>
        <p:nvPicPr>
          <p:cNvPr id="5" name="mAstro-app3xtg Co 24h 09-12-2020">
            <a:hlinkClick r:id="" action="ppaction://media"/>
            <a:extLst>
              <a:ext uri="{FF2B5EF4-FFF2-40B4-BE49-F238E27FC236}">
                <a16:creationId xmlns:a16="http://schemas.microsoft.com/office/drawing/2014/main" id="{4890DFB2-4806-49B1-83A2-AAD10658D530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545225" y="827033"/>
            <a:ext cx="5203934" cy="5203934"/>
          </a:xfrm>
          <a:prstGeom prst="rect">
            <a:avLst/>
          </a:prstGeom>
        </p:spPr>
      </p:pic>
      <p:pic>
        <p:nvPicPr>
          <p:cNvPr id="6" name="mAstro-app3xtg 1uM LOS 24 h 10-12-2020">
            <a:hlinkClick r:id="" action="ppaction://media"/>
            <a:extLst>
              <a:ext uri="{FF2B5EF4-FFF2-40B4-BE49-F238E27FC236}">
                <a16:creationId xmlns:a16="http://schemas.microsoft.com/office/drawing/2014/main" id="{512A476B-A54F-4A2B-B794-C605086D7C5F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>
            <a:lum bright="12000"/>
          </a:blip>
          <a:stretch>
            <a:fillRect/>
          </a:stretch>
        </p:blipFill>
        <p:spPr>
          <a:xfrm>
            <a:off x="5894989" y="827033"/>
            <a:ext cx="5257800" cy="5203934"/>
          </a:xfrm>
          <a:prstGeom prst="rect">
            <a:avLst/>
          </a:prstGeom>
        </p:spPr>
      </p:pic>
      <p:cxnSp>
        <p:nvCxnSpPr>
          <p:cNvPr id="9" name="Gerader Verbinder 8">
            <a:extLst>
              <a:ext uri="{FF2B5EF4-FFF2-40B4-BE49-F238E27FC236}">
                <a16:creationId xmlns:a16="http://schemas.microsoft.com/office/drawing/2014/main" id="{22D966CD-D8DB-4258-9D17-4D06A57383E5}"/>
              </a:ext>
            </a:extLst>
          </p:cNvPr>
          <p:cNvCxnSpPr/>
          <p:nvPr/>
        </p:nvCxnSpPr>
        <p:spPr>
          <a:xfrm>
            <a:off x="10294883" y="5938344"/>
            <a:ext cx="74623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feld 9">
            <a:extLst>
              <a:ext uri="{FF2B5EF4-FFF2-40B4-BE49-F238E27FC236}">
                <a16:creationId xmlns:a16="http://schemas.microsoft.com/office/drawing/2014/main" id="{CF80C5B1-4EF5-4D50-8CDF-0DCC6B44F07E}"/>
              </a:ext>
            </a:extLst>
          </p:cNvPr>
          <p:cNvSpPr txBox="1"/>
          <p:nvPr/>
        </p:nvSpPr>
        <p:spPr>
          <a:xfrm>
            <a:off x="10307706" y="5663603"/>
            <a:ext cx="7008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200</a:t>
            </a:r>
            <a:r>
              <a:rPr lang="el-GR" sz="1400" dirty="0">
                <a:solidFill>
                  <a:schemeClr val="bg1"/>
                </a:solidFill>
              </a:rPr>
              <a:t>μ</a:t>
            </a:r>
            <a:r>
              <a:rPr lang="de-DE" sz="1400" dirty="0">
                <a:solidFill>
                  <a:schemeClr val="bg1"/>
                </a:solidFill>
              </a:rPr>
              <a:t>m</a:t>
            </a:r>
            <a:endParaRPr lang="en-US" sz="1400" dirty="0">
              <a:solidFill>
                <a:schemeClr val="bg1"/>
              </a:solidFill>
            </a:endParaRP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D1BAEDCD-0AB2-4915-AF7A-5C7D3680682C}"/>
              </a:ext>
            </a:extLst>
          </p:cNvPr>
          <p:cNvSpPr txBox="1"/>
          <p:nvPr/>
        </p:nvSpPr>
        <p:spPr>
          <a:xfrm>
            <a:off x="0" y="88080"/>
            <a:ext cx="1219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Supplementary videos to the article “Losartan improves memory, neurogenesis and cell motility in transgenic Alzheimer’s mice” by Drews et al.</a:t>
            </a: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7B4C1549-6C92-479D-B26B-F62521DD9A4B}"/>
              </a:ext>
            </a:extLst>
          </p:cNvPr>
          <p:cNvSpPr txBox="1"/>
          <p:nvPr/>
        </p:nvSpPr>
        <p:spPr>
          <a:xfrm>
            <a:off x="400600" y="506773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291D38ED-91B8-4A2F-9FEC-E36D7E48BAC0}"/>
              </a:ext>
            </a:extLst>
          </p:cNvPr>
          <p:cNvSpPr txBox="1"/>
          <p:nvPr/>
        </p:nvSpPr>
        <p:spPr>
          <a:xfrm>
            <a:off x="5745089" y="512031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98084150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3857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13857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7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1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9" fill="hold">
                      <p:stCondLst>
                        <p:cond delay="0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6</Words>
  <Application>Microsoft Office PowerPoint</Application>
  <PresentationFormat>Breitbild</PresentationFormat>
  <Paragraphs>5</Paragraphs>
  <Slides>1</Slides>
  <Notes>0</Notes>
  <HiddenSlides>0</HiddenSlides>
  <MMClips>2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usine Danielyan</dc:creator>
  <cp:lastModifiedBy>Lusine Danielyan</cp:lastModifiedBy>
  <cp:revision>7</cp:revision>
  <dcterms:created xsi:type="dcterms:W3CDTF">2021-01-11T10:56:35Z</dcterms:created>
  <dcterms:modified xsi:type="dcterms:W3CDTF">2021-01-20T16:04:01Z</dcterms:modified>
</cp:coreProperties>
</file>